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128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RF0308\Desktop\MND\PathDxCoPath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93688288963881"/>
          <c:y val="0.10675833134494551"/>
          <c:w val="0.67881155480564925"/>
          <c:h val="0.86394197884355362"/>
        </c:manualLayout>
      </c:layout>
      <c:pieChart>
        <c:varyColors val="1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3"/>
            <c:bubble3D val="0"/>
            <c:spPr>
              <a:solidFill>
                <a:schemeClr val="accent3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4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6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7"/>
            <c:bubble3D val="0"/>
            <c:spPr>
              <a:solidFill>
                <a:schemeClr val="accent2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8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9"/>
            <c:bubble3D val="0"/>
            <c:spPr>
              <a:solidFill>
                <a:schemeClr val="accent4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0"/>
            <c:bubble3D val="0"/>
            <c:spPr>
              <a:solidFill>
                <a:schemeClr val="accent4">
                  <a:lumMod val="40000"/>
                  <a:lumOff val="6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Lbls>
            <c:dLbl>
              <c:idx val="9"/>
              <c:layout>
                <c:manualLayout>
                  <c:x val="4.0211324356325101E-2"/>
                  <c:y val="-3.0190179157375172E-3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10"/>
              <c:layout>
                <c:manualLayout>
                  <c:x val="3.0103501213291736E-2"/>
                  <c:y val="-9.5293105915753729E-3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</c:dLbl>
            <c:txPr>
              <a:bodyPr/>
              <a:lstStyle/>
              <a:p>
                <a:pPr>
                  <a:defRPr sz="1200" b="1" i="0" baseline="0">
                    <a:solidFill>
                      <a:schemeClr val="tx1"/>
                    </a:solidFill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Sheet14!$A$7:$A$17</c:f>
              <c:strCache>
                <c:ptCount val="11"/>
                <c:pt idx="0">
                  <c:v>AD</c:v>
                </c:pt>
                <c:pt idx="1">
                  <c:v>AD/LBD</c:v>
                </c:pt>
                <c:pt idx="2">
                  <c:v>AD/LBD+</c:v>
                </c:pt>
                <c:pt idx="3">
                  <c:v>AD/Vas</c:v>
                </c:pt>
                <c:pt idx="4">
                  <c:v>AD/Vas+</c:v>
                </c:pt>
                <c:pt idx="5">
                  <c:v>AD/CAA</c:v>
                </c:pt>
                <c:pt idx="6">
                  <c:v>AD/CAA+</c:v>
                </c:pt>
                <c:pt idx="7">
                  <c:v>AD/HpScl</c:v>
                </c:pt>
                <c:pt idx="8">
                  <c:v>AD/HpScl+</c:v>
                </c:pt>
                <c:pt idx="9">
                  <c:v>AD/Other</c:v>
                </c:pt>
                <c:pt idx="10">
                  <c:v>AD/Other+</c:v>
                </c:pt>
              </c:strCache>
            </c:strRef>
          </c:cat>
          <c:val>
            <c:numRef>
              <c:f>Sheet14!$B$7:$B$17</c:f>
              <c:numCache>
                <c:formatCode>General</c:formatCode>
                <c:ptCount val="11"/>
                <c:pt idx="0">
                  <c:v>243</c:v>
                </c:pt>
                <c:pt idx="1">
                  <c:v>175</c:v>
                </c:pt>
                <c:pt idx="2">
                  <c:v>206</c:v>
                </c:pt>
                <c:pt idx="3">
                  <c:v>113</c:v>
                </c:pt>
                <c:pt idx="4">
                  <c:v>77</c:v>
                </c:pt>
                <c:pt idx="5">
                  <c:v>42</c:v>
                </c:pt>
                <c:pt idx="6">
                  <c:v>110</c:v>
                </c:pt>
                <c:pt idx="7">
                  <c:v>27</c:v>
                </c:pt>
                <c:pt idx="8">
                  <c:v>51</c:v>
                </c:pt>
                <c:pt idx="9">
                  <c:v>59</c:v>
                </c:pt>
                <c:pt idx="10">
                  <c:v>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239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720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59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63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248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317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13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11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439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853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543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77580-D189-4E7E-9097-DB6B9497419B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FA15A-E6C9-4B39-A043-7EE7CD729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818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3363575102"/>
              </p:ext>
            </p:extLst>
          </p:nvPr>
        </p:nvGraphicFramePr>
        <p:xfrm>
          <a:off x="1371600" y="685800"/>
          <a:ext cx="6400800" cy="502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5800" y="5791200"/>
            <a:ext cx="25637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upplemental Figure 1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775032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 Deture</dc:creator>
  <cp:lastModifiedBy>Michael  Deture</cp:lastModifiedBy>
  <cp:revision>4</cp:revision>
  <dcterms:created xsi:type="dcterms:W3CDTF">2018-10-07T16:25:19Z</dcterms:created>
  <dcterms:modified xsi:type="dcterms:W3CDTF">2018-10-07T16:37:46Z</dcterms:modified>
</cp:coreProperties>
</file>